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4" r:id="rId3"/>
    <p:sldId id="263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6C6B5B3-A706-4C4D-ADD1-BC25D55FF839}" v="23" dt="2024-11-12T00:53:49.89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108" y="1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성균 박" userId="475b0f278f8dc192" providerId="LiveId" clId="{70F84619-8297-4762-BE17-76F80C3A3130}"/>
    <pc:docChg chg="undo custSel addSld delSld modSld">
      <pc:chgData name="성균 박" userId="475b0f278f8dc192" providerId="LiveId" clId="{70F84619-8297-4762-BE17-76F80C3A3130}" dt="2024-09-03T04:22:07.120" v="489" actId="20577"/>
      <pc:docMkLst>
        <pc:docMk/>
      </pc:docMkLst>
      <pc:sldChg chg="new del">
        <pc:chgData name="성균 박" userId="475b0f278f8dc192" providerId="LiveId" clId="{70F84619-8297-4762-BE17-76F80C3A3130}" dt="2024-09-03T03:20:46.737" v="4" actId="47"/>
        <pc:sldMkLst>
          <pc:docMk/>
          <pc:sldMk cId="1796449464" sldId="256"/>
        </pc:sldMkLst>
      </pc:sldChg>
      <pc:sldChg chg="addSp delSp modSp new mod">
        <pc:chgData name="성균 박" userId="475b0f278f8dc192" providerId="LiveId" clId="{70F84619-8297-4762-BE17-76F80C3A3130}" dt="2024-09-03T03:21:22.450" v="26" actId="1076"/>
        <pc:sldMkLst>
          <pc:docMk/>
          <pc:sldMk cId="858820365" sldId="257"/>
        </pc:sldMkLst>
        <pc:spChg chg="del">
          <ac:chgData name="성균 박" userId="475b0f278f8dc192" providerId="LiveId" clId="{70F84619-8297-4762-BE17-76F80C3A3130}" dt="2024-09-03T03:20:45.280" v="2" actId="478"/>
          <ac:spMkLst>
            <pc:docMk/>
            <pc:sldMk cId="858820365" sldId="257"/>
            <ac:spMk id="2" creationId="{E1024B8A-5E68-7E79-EDD8-909AB8289B59}"/>
          </ac:spMkLst>
        </pc:spChg>
        <pc:spChg chg="del">
          <ac:chgData name="성균 박" userId="475b0f278f8dc192" providerId="LiveId" clId="{70F84619-8297-4762-BE17-76F80C3A3130}" dt="2024-09-03T03:20:46.246" v="3" actId="478"/>
          <ac:spMkLst>
            <pc:docMk/>
            <pc:sldMk cId="858820365" sldId="257"/>
            <ac:spMk id="3" creationId="{D8A4EDFC-4F73-E488-F24B-4FCBF6738F33}"/>
          </ac:spMkLst>
        </pc:spChg>
        <pc:spChg chg="add mod">
          <ac:chgData name="성균 박" userId="475b0f278f8dc192" providerId="LiveId" clId="{70F84619-8297-4762-BE17-76F80C3A3130}" dt="2024-09-03T03:21:22.450" v="26" actId="1076"/>
          <ac:spMkLst>
            <pc:docMk/>
            <pc:sldMk cId="858820365" sldId="257"/>
            <ac:spMk id="4" creationId="{143F6CAA-F722-24A9-5DB1-820252810103}"/>
          </ac:spMkLst>
        </pc:spChg>
        <pc:picChg chg="add mod">
          <ac:chgData name="성균 박" userId="475b0f278f8dc192" providerId="LiveId" clId="{70F84619-8297-4762-BE17-76F80C3A3130}" dt="2024-09-03T03:21:20.023" v="25" actId="1076"/>
          <ac:picMkLst>
            <pc:docMk/>
            <pc:sldMk cId="858820365" sldId="257"/>
            <ac:picMk id="5" creationId="{5620FF3D-33C6-F925-93C6-C3B832E27712}"/>
          </ac:picMkLst>
        </pc:picChg>
      </pc:sldChg>
      <pc:sldChg chg="addSp delSp modSp add mod">
        <pc:chgData name="성균 박" userId="475b0f278f8dc192" providerId="LiveId" clId="{70F84619-8297-4762-BE17-76F80C3A3130}" dt="2024-09-03T04:22:03.601" v="487" actId="20577"/>
        <pc:sldMkLst>
          <pc:docMk/>
          <pc:sldMk cId="2658513804" sldId="258"/>
        </pc:sldMkLst>
        <pc:spChg chg="mod">
          <ac:chgData name="성균 박" userId="475b0f278f8dc192" providerId="LiveId" clId="{70F84619-8297-4762-BE17-76F80C3A3130}" dt="2024-09-03T04:22:03.601" v="487" actId="20577"/>
          <ac:spMkLst>
            <pc:docMk/>
            <pc:sldMk cId="2658513804" sldId="258"/>
            <ac:spMk id="4" creationId="{143F6CAA-F722-24A9-5DB1-820252810103}"/>
          </ac:spMkLst>
        </pc:spChg>
        <pc:spChg chg="add mod">
          <ac:chgData name="성균 박" userId="475b0f278f8dc192" providerId="LiveId" clId="{70F84619-8297-4762-BE17-76F80C3A3130}" dt="2024-09-03T04:20:20.522" v="482" actId="164"/>
          <ac:spMkLst>
            <pc:docMk/>
            <pc:sldMk cId="2658513804" sldId="258"/>
            <ac:spMk id="6" creationId="{8EE3AF49-2969-5489-DF95-ACDB492EC032}"/>
          </ac:spMkLst>
        </pc:spChg>
        <pc:spChg chg="add mod">
          <ac:chgData name="성균 박" userId="475b0f278f8dc192" providerId="LiveId" clId="{70F84619-8297-4762-BE17-76F80C3A3130}" dt="2024-09-03T04:20:20.522" v="482" actId="164"/>
          <ac:spMkLst>
            <pc:docMk/>
            <pc:sldMk cId="2658513804" sldId="258"/>
            <ac:spMk id="7" creationId="{FDCCDA69-2446-7E60-973A-67DE452044C9}"/>
          </ac:spMkLst>
        </pc:spChg>
        <pc:grpChg chg="add mod">
          <ac:chgData name="성균 박" userId="475b0f278f8dc192" providerId="LiveId" clId="{70F84619-8297-4762-BE17-76F80C3A3130}" dt="2024-09-03T04:20:20.522" v="482" actId="164"/>
          <ac:grpSpMkLst>
            <pc:docMk/>
            <pc:sldMk cId="2658513804" sldId="258"/>
            <ac:grpSpMk id="8" creationId="{63B66724-AE94-2BA1-8256-900578ABCC05}"/>
          </ac:grpSpMkLst>
        </pc:grpChg>
        <pc:picChg chg="add mod">
          <ac:chgData name="성균 박" userId="475b0f278f8dc192" providerId="LiveId" clId="{70F84619-8297-4762-BE17-76F80C3A3130}" dt="2024-09-03T04:20:20.522" v="482" actId="164"/>
          <ac:picMkLst>
            <pc:docMk/>
            <pc:sldMk cId="2658513804" sldId="258"/>
            <ac:picMk id="2" creationId="{288AF067-C226-7338-6CCD-1D4EEA95A3FD}"/>
          </ac:picMkLst>
        </pc:picChg>
        <pc:picChg chg="add mod">
          <ac:chgData name="성균 박" userId="475b0f278f8dc192" providerId="LiveId" clId="{70F84619-8297-4762-BE17-76F80C3A3130}" dt="2024-09-03T04:20:20.522" v="482" actId="164"/>
          <ac:picMkLst>
            <pc:docMk/>
            <pc:sldMk cId="2658513804" sldId="258"/>
            <ac:picMk id="3" creationId="{AB9D207A-2B02-2B72-A0EC-18B3CFD18837}"/>
          </ac:picMkLst>
        </pc:picChg>
        <pc:picChg chg="del">
          <ac:chgData name="성균 박" userId="475b0f278f8dc192" providerId="LiveId" clId="{70F84619-8297-4762-BE17-76F80C3A3130}" dt="2024-09-03T03:21:29.471" v="28" actId="478"/>
          <ac:picMkLst>
            <pc:docMk/>
            <pc:sldMk cId="2658513804" sldId="258"/>
            <ac:picMk id="5" creationId="{5620FF3D-33C6-F925-93C6-C3B832E27712}"/>
          </ac:picMkLst>
        </pc:picChg>
      </pc:sldChg>
      <pc:sldChg chg="delSp new del mod">
        <pc:chgData name="성균 박" userId="475b0f278f8dc192" providerId="LiveId" clId="{70F84619-8297-4762-BE17-76F80C3A3130}" dt="2024-09-03T04:09:21.353" v="203" actId="47"/>
        <pc:sldMkLst>
          <pc:docMk/>
          <pc:sldMk cId="1993848786" sldId="259"/>
        </pc:sldMkLst>
        <pc:spChg chg="del">
          <ac:chgData name="성균 박" userId="475b0f278f8dc192" providerId="LiveId" clId="{70F84619-8297-4762-BE17-76F80C3A3130}" dt="2024-09-03T04:09:16.603" v="200" actId="478"/>
          <ac:spMkLst>
            <pc:docMk/>
            <pc:sldMk cId="1993848786" sldId="259"/>
            <ac:spMk id="2" creationId="{C93B3F80-7F5B-5BF3-8854-DBB03F074A8D}"/>
          </ac:spMkLst>
        </pc:spChg>
        <pc:spChg chg="del">
          <ac:chgData name="성균 박" userId="475b0f278f8dc192" providerId="LiveId" clId="{70F84619-8297-4762-BE17-76F80C3A3130}" dt="2024-09-03T04:09:17.300" v="201" actId="478"/>
          <ac:spMkLst>
            <pc:docMk/>
            <pc:sldMk cId="1993848786" sldId="259"/>
            <ac:spMk id="3" creationId="{E6DCAF05-6AFB-3889-7D0F-E77A6D7DF4EF}"/>
          </ac:spMkLst>
        </pc:spChg>
      </pc:sldChg>
      <pc:sldChg chg="modSp add del mod">
        <pc:chgData name="성균 박" userId="475b0f278f8dc192" providerId="LiveId" clId="{70F84619-8297-4762-BE17-76F80C3A3130}" dt="2024-09-03T04:17:42.998" v="440" actId="47"/>
        <pc:sldMkLst>
          <pc:docMk/>
          <pc:sldMk cId="1636597166" sldId="260"/>
        </pc:sldMkLst>
        <pc:spChg chg="mod">
          <ac:chgData name="성균 박" userId="475b0f278f8dc192" providerId="LiveId" clId="{70F84619-8297-4762-BE17-76F80C3A3130}" dt="2024-09-03T04:15:54.918" v="415" actId="1076"/>
          <ac:spMkLst>
            <pc:docMk/>
            <pc:sldMk cId="1636597166" sldId="260"/>
            <ac:spMk id="4" creationId="{143F6CAA-F722-24A9-5DB1-820252810103}"/>
          </ac:spMkLst>
        </pc:spChg>
      </pc:sldChg>
      <pc:sldChg chg="addSp modSp add mod">
        <pc:chgData name="성균 박" userId="475b0f278f8dc192" providerId="LiveId" clId="{70F84619-8297-4762-BE17-76F80C3A3130}" dt="2024-09-03T04:22:07.120" v="489" actId="20577"/>
        <pc:sldMkLst>
          <pc:docMk/>
          <pc:sldMk cId="4177297690" sldId="261"/>
        </pc:sldMkLst>
        <pc:spChg chg="mod">
          <ac:chgData name="성균 박" userId="475b0f278f8dc192" providerId="LiveId" clId="{70F84619-8297-4762-BE17-76F80C3A3130}" dt="2024-09-03T04:22:07.120" v="489" actId="20577"/>
          <ac:spMkLst>
            <pc:docMk/>
            <pc:sldMk cId="4177297690" sldId="261"/>
            <ac:spMk id="4" creationId="{143F6CAA-F722-24A9-5DB1-820252810103}"/>
          </ac:spMkLst>
        </pc:spChg>
        <pc:spChg chg="mod">
          <ac:chgData name="성균 박" userId="475b0f278f8dc192" providerId="LiveId" clId="{70F84619-8297-4762-BE17-76F80C3A3130}" dt="2024-09-03T04:20:26.031" v="483" actId="164"/>
          <ac:spMkLst>
            <pc:docMk/>
            <pc:sldMk cId="4177297690" sldId="261"/>
            <ac:spMk id="6" creationId="{8EE3AF49-2969-5489-DF95-ACDB492EC032}"/>
          </ac:spMkLst>
        </pc:spChg>
        <pc:spChg chg="mod">
          <ac:chgData name="성균 박" userId="475b0f278f8dc192" providerId="LiveId" clId="{70F84619-8297-4762-BE17-76F80C3A3130}" dt="2024-09-03T04:20:26.031" v="483" actId="164"/>
          <ac:spMkLst>
            <pc:docMk/>
            <pc:sldMk cId="4177297690" sldId="261"/>
            <ac:spMk id="7" creationId="{FDCCDA69-2446-7E60-973A-67DE452044C9}"/>
          </ac:spMkLst>
        </pc:spChg>
        <pc:grpChg chg="add mod">
          <ac:chgData name="성균 박" userId="475b0f278f8dc192" providerId="LiveId" clId="{70F84619-8297-4762-BE17-76F80C3A3130}" dt="2024-09-03T04:20:26.031" v="483" actId="164"/>
          <ac:grpSpMkLst>
            <pc:docMk/>
            <pc:sldMk cId="4177297690" sldId="261"/>
            <ac:grpSpMk id="5" creationId="{4B144AE9-0A4A-1218-00E0-F67959978B7D}"/>
          </ac:grpSpMkLst>
        </pc:grpChg>
        <pc:picChg chg="mod">
          <ac:chgData name="성균 박" userId="475b0f278f8dc192" providerId="LiveId" clId="{70F84619-8297-4762-BE17-76F80C3A3130}" dt="2024-09-03T04:20:26.031" v="483" actId="164"/>
          <ac:picMkLst>
            <pc:docMk/>
            <pc:sldMk cId="4177297690" sldId="261"/>
            <ac:picMk id="2" creationId="{288AF067-C226-7338-6CCD-1D4EEA95A3FD}"/>
          </ac:picMkLst>
        </pc:picChg>
        <pc:picChg chg="mod">
          <ac:chgData name="성균 박" userId="475b0f278f8dc192" providerId="LiveId" clId="{70F84619-8297-4762-BE17-76F80C3A3130}" dt="2024-09-03T04:20:26.031" v="483" actId="164"/>
          <ac:picMkLst>
            <pc:docMk/>
            <pc:sldMk cId="4177297690" sldId="261"/>
            <ac:picMk id="3" creationId="{AB9D207A-2B02-2B72-A0EC-18B3CFD18837}"/>
          </ac:picMkLst>
        </pc:picChg>
      </pc:sldChg>
    </pc:docChg>
  </pc:docChgLst>
  <pc:docChgLst>
    <pc:chgData name="성균 박" userId="475b0f278f8dc192" providerId="LiveId" clId="{6AA5C71B-F192-4FAA-A4CF-9442B5DCEB45}"/>
    <pc:docChg chg="custSel addSld delSld modSld">
      <pc:chgData name="성균 박" userId="475b0f278f8dc192" providerId="LiveId" clId="{6AA5C71B-F192-4FAA-A4CF-9442B5DCEB45}" dt="2024-11-08T09:54:31.161" v="19" actId="47"/>
      <pc:docMkLst>
        <pc:docMk/>
      </pc:docMkLst>
      <pc:sldChg chg="modSp mod">
        <pc:chgData name="성균 박" userId="475b0f278f8dc192" providerId="LiveId" clId="{6AA5C71B-F192-4FAA-A4CF-9442B5DCEB45}" dt="2024-09-20T09:25:22.528" v="15" actId="6549"/>
        <pc:sldMkLst>
          <pc:docMk/>
          <pc:sldMk cId="4177297690" sldId="261"/>
        </pc:sldMkLst>
        <pc:spChg chg="mod">
          <ac:chgData name="성균 박" userId="475b0f278f8dc192" providerId="LiveId" clId="{6AA5C71B-F192-4FAA-A4CF-9442B5DCEB45}" dt="2024-09-20T09:25:22.528" v="15" actId="6549"/>
          <ac:spMkLst>
            <pc:docMk/>
            <pc:sldMk cId="4177297690" sldId="261"/>
            <ac:spMk id="4" creationId="{143F6CAA-F722-24A9-5DB1-820252810103}"/>
          </ac:spMkLst>
        </pc:spChg>
      </pc:sldChg>
      <pc:sldChg chg="delSp new del mod">
        <pc:chgData name="성균 박" userId="475b0f278f8dc192" providerId="LiveId" clId="{6AA5C71B-F192-4FAA-A4CF-9442B5DCEB45}" dt="2024-11-08T09:54:31.161" v="19" actId="47"/>
        <pc:sldMkLst>
          <pc:docMk/>
          <pc:sldMk cId="1818885140" sldId="262"/>
        </pc:sldMkLst>
        <pc:spChg chg="del">
          <ac:chgData name="성균 박" userId="475b0f278f8dc192" providerId="LiveId" clId="{6AA5C71B-F192-4FAA-A4CF-9442B5DCEB45}" dt="2024-11-08T09:35:35.357" v="17" actId="478"/>
          <ac:spMkLst>
            <pc:docMk/>
            <pc:sldMk cId="1818885140" sldId="262"/>
            <ac:spMk id="2" creationId="{AC78B6BD-0F13-9B8F-750E-0B238C29270A}"/>
          </ac:spMkLst>
        </pc:spChg>
        <pc:spChg chg="del">
          <ac:chgData name="성균 박" userId="475b0f278f8dc192" providerId="LiveId" clId="{6AA5C71B-F192-4FAA-A4CF-9442B5DCEB45}" dt="2024-11-08T09:35:36.415" v="18" actId="478"/>
          <ac:spMkLst>
            <pc:docMk/>
            <pc:sldMk cId="1818885140" sldId="262"/>
            <ac:spMk id="3" creationId="{A1A403EC-5D5A-5D25-242E-39693FBCBDF7}"/>
          </ac:spMkLst>
        </pc:spChg>
      </pc:sldChg>
    </pc:docChg>
  </pc:docChgLst>
  <pc:docChgLst>
    <pc:chgData name="성균 박" userId="475b0f278f8dc192" providerId="LiveId" clId="{84865290-1500-490C-BE6B-B7C80C822EC0}"/>
    <pc:docChg chg="delSld">
      <pc:chgData name="성균 박" userId="475b0f278f8dc192" providerId="LiveId" clId="{84865290-1500-490C-BE6B-B7C80C822EC0}" dt="2024-09-03T05:33:51.096" v="0" actId="47"/>
      <pc:docMkLst>
        <pc:docMk/>
      </pc:docMkLst>
      <pc:sldChg chg="del">
        <pc:chgData name="성균 박" userId="475b0f278f8dc192" providerId="LiveId" clId="{84865290-1500-490C-BE6B-B7C80C822EC0}" dt="2024-09-03T05:33:51.096" v="0" actId="47"/>
        <pc:sldMkLst>
          <pc:docMk/>
          <pc:sldMk cId="858820365" sldId="257"/>
        </pc:sldMkLst>
      </pc:sldChg>
      <pc:sldChg chg="del">
        <pc:chgData name="성균 박" userId="475b0f278f8dc192" providerId="LiveId" clId="{84865290-1500-490C-BE6B-B7C80C822EC0}" dt="2024-09-03T05:33:51.096" v="0" actId="47"/>
        <pc:sldMkLst>
          <pc:docMk/>
          <pc:sldMk cId="2658513804" sldId="258"/>
        </pc:sldMkLst>
      </pc:sldChg>
    </pc:docChg>
  </pc:docChgLst>
  <pc:docChgLst>
    <pc:chgData name="성균 박" userId="475b0f278f8dc192" providerId="LiveId" clId="{46C6B5B3-A706-4C4D-ADD1-BC25D55FF839}"/>
    <pc:docChg chg="undo custSel addSld delSld modSld">
      <pc:chgData name="성균 박" userId="475b0f278f8dc192" providerId="LiveId" clId="{46C6B5B3-A706-4C4D-ADD1-BC25D55FF839}" dt="2024-11-12T00:55:25.786" v="410" actId="20577"/>
      <pc:docMkLst>
        <pc:docMk/>
      </pc:docMkLst>
      <pc:sldChg chg="addSp delSp modSp new del mod">
        <pc:chgData name="성균 박" userId="475b0f278f8dc192" providerId="LiveId" clId="{46C6B5B3-A706-4C4D-ADD1-BC25D55FF839}" dt="2024-11-12T00:53:28.890" v="307" actId="47"/>
        <pc:sldMkLst>
          <pc:docMk/>
          <pc:sldMk cId="2454202280" sldId="262"/>
        </pc:sldMkLst>
        <pc:spChg chg="del">
          <ac:chgData name="성균 박" userId="475b0f278f8dc192" providerId="LiveId" clId="{46C6B5B3-A706-4C4D-ADD1-BC25D55FF839}" dt="2024-11-08T09:55:03.407" v="4" actId="478"/>
          <ac:spMkLst>
            <pc:docMk/>
            <pc:sldMk cId="2454202280" sldId="262"/>
            <ac:spMk id="2" creationId="{EDB1AB50-93BB-2F01-8EBB-337707959BB8}"/>
          </ac:spMkLst>
        </pc:spChg>
        <pc:spChg chg="del mod">
          <ac:chgData name="성균 박" userId="475b0f278f8dc192" providerId="LiveId" clId="{46C6B5B3-A706-4C4D-ADD1-BC25D55FF839}" dt="2024-11-08T09:55:02.178" v="3" actId="478"/>
          <ac:spMkLst>
            <pc:docMk/>
            <pc:sldMk cId="2454202280" sldId="262"/>
            <ac:spMk id="3" creationId="{86DC45A0-979D-71B1-D1E5-A06F4A6ED685}"/>
          </ac:spMkLst>
        </pc:spChg>
        <pc:spChg chg="add">
          <ac:chgData name="성균 박" userId="475b0f278f8dc192" providerId="LiveId" clId="{46C6B5B3-A706-4C4D-ADD1-BC25D55FF839}" dt="2024-11-08T09:55:08.094" v="5"/>
          <ac:spMkLst>
            <pc:docMk/>
            <pc:sldMk cId="2454202280" sldId="262"/>
            <ac:spMk id="5" creationId="{C8BE0B24-397C-C5EB-2524-BF678BA6193B}"/>
          </ac:spMkLst>
        </pc:spChg>
        <pc:spChg chg="add mod">
          <ac:chgData name="성균 박" userId="475b0f278f8dc192" providerId="LiveId" clId="{46C6B5B3-A706-4C4D-ADD1-BC25D55FF839}" dt="2024-11-08T09:58:16.487" v="108" actId="164"/>
          <ac:spMkLst>
            <pc:docMk/>
            <pc:sldMk cId="2454202280" sldId="262"/>
            <ac:spMk id="7" creationId="{CC7E9784-5990-D04E-D200-E0C28ED093ED}"/>
          </ac:spMkLst>
        </pc:spChg>
        <pc:spChg chg="add mod">
          <ac:chgData name="성균 박" userId="475b0f278f8dc192" providerId="LiveId" clId="{46C6B5B3-A706-4C4D-ADD1-BC25D55FF839}" dt="2024-11-08T09:58:16.487" v="108" actId="164"/>
          <ac:spMkLst>
            <pc:docMk/>
            <pc:sldMk cId="2454202280" sldId="262"/>
            <ac:spMk id="8" creationId="{09774498-F743-CA0B-5C97-6D49CF0525AC}"/>
          </ac:spMkLst>
        </pc:spChg>
        <pc:spChg chg="add mod">
          <ac:chgData name="성균 박" userId="475b0f278f8dc192" providerId="LiveId" clId="{46C6B5B3-A706-4C4D-ADD1-BC25D55FF839}" dt="2024-11-08T09:58:16.487" v="108" actId="164"/>
          <ac:spMkLst>
            <pc:docMk/>
            <pc:sldMk cId="2454202280" sldId="262"/>
            <ac:spMk id="9" creationId="{8440EEAB-F140-4E36-8B07-0D3CAFBAE91E}"/>
          </ac:spMkLst>
        </pc:spChg>
        <pc:spChg chg="add del mod">
          <ac:chgData name="성균 박" userId="475b0f278f8dc192" providerId="LiveId" clId="{46C6B5B3-A706-4C4D-ADD1-BC25D55FF839}" dt="2024-11-08T09:57:35.445" v="103" actId="478"/>
          <ac:spMkLst>
            <pc:docMk/>
            <pc:sldMk cId="2454202280" sldId="262"/>
            <ac:spMk id="10" creationId="{8298950F-32A4-5944-3C0C-AA93B13E5663}"/>
          </ac:spMkLst>
        </pc:spChg>
        <pc:spChg chg="add del mod">
          <ac:chgData name="성균 박" userId="475b0f278f8dc192" providerId="LiveId" clId="{46C6B5B3-A706-4C4D-ADD1-BC25D55FF839}" dt="2024-11-08T09:57:35.445" v="103" actId="478"/>
          <ac:spMkLst>
            <pc:docMk/>
            <pc:sldMk cId="2454202280" sldId="262"/>
            <ac:spMk id="11" creationId="{CBE7E8EC-6528-2D44-96C6-A87558C8F108}"/>
          </ac:spMkLst>
        </pc:spChg>
        <pc:spChg chg="add mod">
          <ac:chgData name="성균 박" userId="475b0f278f8dc192" providerId="LiveId" clId="{46C6B5B3-A706-4C4D-ADD1-BC25D55FF839}" dt="2024-11-08T09:58:16.487" v="108" actId="164"/>
          <ac:spMkLst>
            <pc:docMk/>
            <pc:sldMk cId="2454202280" sldId="262"/>
            <ac:spMk id="12" creationId="{A7A231A1-973C-D44E-F902-06B3C29E3645}"/>
          </ac:spMkLst>
        </pc:spChg>
        <pc:spChg chg="add mod">
          <ac:chgData name="성균 박" userId="475b0f278f8dc192" providerId="LiveId" clId="{46C6B5B3-A706-4C4D-ADD1-BC25D55FF839}" dt="2024-11-12T00:36:53.478" v="295" actId="1076"/>
          <ac:spMkLst>
            <pc:docMk/>
            <pc:sldMk cId="2454202280" sldId="262"/>
            <ac:spMk id="15" creationId="{9C0A5770-B296-6579-765F-160A0D9D59C6}"/>
          </ac:spMkLst>
        </pc:spChg>
        <pc:spChg chg="add del mod topLvl">
          <ac:chgData name="성균 박" userId="475b0f278f8dc192" providerId="LiveId" clId="{46C6B5B3-A706-4C4D-ADD1-BC25D55FF839}" dt="2024-11-08T09:59:45.982" v="222" actId="478"/>
          <ac:spMkLst>
            <pc:docMk/>
            <pc:sldMk cId="2454202280" sldId="262"/>
            <ac:spMk id="16" creationId="{317B40C9-1DAA-BF08-7B71-86440AF072F6}"/>
          </ac:spMkLst>
        </pc:spChg>
        <pc:grpChg chg="add mod topLvl">
          <ac:chgData name="성균 박" userId="475b0f278f8dc192" providerId="LiveId" clId="{46C6B5B3-A706-4C4D-ADD1-BC25D55FF839}" dt="2024-11-12T00:36:50.853" v="294" actId="14100"/>
          <ac:grpSpMkLst>
            <pc:docMk/>
            <pc:sldMk cId="2454202280" sldId="262"/>
            <ac:grpSpMk id="13" creationId="{F1571659-F206-C7C7-F89D-92E1D10EEE95}"/>
          </ac:grpSpMkLst>
        </pc:grpChg>
        <pc:grpChg chg="add del mod">
          <ac:chgData name="성균 박" userId="475b0f278f8dc192" providerId="LiveId" clId="{46C6B5B3-A706-4C4D-ADD1-BC25D55FF839}" dt="2024-11-08T09:59:45.982" v="222" actId="478"/>
          <ac:grpSpMkLst>
            <pc:docMk/>
            <pc:sldMk cId="2454202280" sldId="262"/>
            <ac:grpSpMk id="17" creationId="{728BACA2-34FB-146A-98B5-55D122DFD30D}"/>
          </ac:grpSpMkLst>
        </pc:grpChg>
        <pc:graphicFrameChg chg="del">
          <ac:chgData name="성균 박" userId="475b0f278f8dc192" providerId="LiveId" clId="{46C6B5B3-A706-4C4D-ADD1-BC25D55FF839}" dt="2024-11-08T09:55:01.379" v="1" actId="478"/>
          <ac:graphicFrameMkLst>
            <pc:docMk/>
            <pc:sldMk cId="2454202280" sldId="262"/>
            <ac:graphicFrameMk id="4" creationId="{0A5BBE2A-6873-3EB0-0E86-6ED7BED5F414}"/>
          </ac:graphicFrameMkLst>
        </pc:graphicFrameChg>
        <pc:picChg chg="add mod">
          <ac:chgData name="성균 박" userId="475b0f278f8dc192" providerId="LiveId" clId="{46C6B5B3-A706-4C4D-ADD1-BC25D55FF839}" dt="2024-11-08T09:58:16.487" v="108" actId="164"/>
          <ac:picMkLst>
            <pc:docMk/>
            <pc:sldMk cId="2454202280" sldId="262"/>
            <ac:picMk id="6" creationId="{0EFDD6B6-5F92-4E57-DA22-C6C79B10A7AF}"/>
          </ac:picMkLst>
        </pc:picChg>
      </pc:sldChg>
      <pc:sldChg chg="delSp modSp add mod">
        <pc:chgData name="성균 박" userId="475b0f278f8dc192" providerId="LiveId" clId="{46C6B5B3-A706-4C4D-ADD1-BC25D55FF839}" dt="2024-11-12T00:55:25.786" v="410" actId="20577"/>
        <pc:sldMkLst>
          <pc:docMk/>
          <pc:sldMk cId="452801974" sldId="263"/>
        </pc:sldMkLst>
        <pc:spChg chg="mod topLvl">
          <ac:chgData name="성균 박" userId="475b0f278f8dc192" providerId="LiveId" clId="{46C6B5B3-A706-4C4D-ADD1-BC25D55FF839}" dt="2024-11-12T00:54:58.594" v="405" actId="1036"/>
          <ac:spMkLst>
            <pc:docMk/>
            <pc:sldMk cId="452801974" sldId="263"/>
            <ac:spMk id="7" creationId="{B99751F7-FDC0-A7F2-5E80-B6DA64CFCEFF}"/>
          </ac:spMkLst>
        </pc:spChg>
        <pc:spChg chg="mod topLvl">
          <ac:chgData name="성균 박" userId="475b0f278f8dc192" providerId="LiveId" clId="{46C6B5B3-A706-4C4D-ADD1-BC25D55FF839}" dt="2024-11-12T00:54:53.296" v="397" actId="1036"/>
          <ac:spMkLst>
            <pc:docMk/>
            <pc:sldMk cId="452801974" sldId="263"/>
            <ac:spMk id="8" creationId="{C32D4C8E-4E1A-A8DC-0B2D-45DAC1020DB2}"/>
          </ac:spMkLst>
        </pc:spChg>
        <pc:spChg chg="mod topLvl">
          <ac:chgData name="성균 박" userId="475b0f278f8dc192" providerId="LiveId" clId="{46C6B5B3-A706-4C4D-ADD1-BC25D55FF839}" dt="2024-11-12T00:54:38.001" v="350" actId="1035"/>
          <ac:spMkLst>
            <pc:docMk/>
            <pc:sldMk cId="452801974" sldId="263"/>
            <ac:spMk id="9" creationId="{907CEB64-7ED9-BFEA-ED84-C43C7F43D764}"/>
          </ac:spMkLst>
        </pc:spChg>
        <pc:spChg chg="mod topLvl">
          <ac:chgData name="성균 박" userId="475b0f278f8dc192" providerId="LiveId" clId="{46C6B5B3-A706-4C4D-ADD1-BC25D55FF839}" dt="2024-11-12T00:54:44.361" v="363" actId="1035"/>
          <ac:spMkLst>
            <pc:docMk/>
            <pc:sldMk cId="452801974" sldId="263"/>
            <ac:spMk id="12" creationId="{4E3035FC-4162-4A88-D81C-EB8D9746D450}"/>
          </ac:spMkLst>
        </pc:spChg>
        <pc:spChg chg="mod">
          <ac:chgData name="성균 박" userId="475b0f278f8dc192" providerId="LiveId" clId="{46C6B5B3-A706-4C4D-ADD1-BC25D55FF839}" dt="2024-11-12T00:55:25.786" v="410" actId="20577"/>
          <ac:spMkLst>
            <pc:docMk/>
            <pc:sldMk cId="452801974" sldId="263"/>
            <ac:spMk id="15" creationId="{8D82B95B-8B99-0465-294E-3573F3BEFE0E}"/>
          </ac:spMkLst>
        </pc:spChg>
        <pc:grpChg chg="del mod">
          <ac:chgData name="성균 박" userId="475b0f278f8dc192" providerId="LiveId" clId="{46C6B5B3-A706-4C4D-ADD1-BC25D55FF839}" dt="2024-11-12T00:53:49.894" v="308" actId="165"/>
          <ac:grpSpMkLst>
            <pc:docMk/>
            <pc:sldMk cId="452801974" sldId="263"/>
            <ac:grpSpMk id="13" creationId="{05B34856-F9C9-EB71-32FB-A16C31EC2D58}"/>
          </ac:grpSpMkLst>
        </pc:grpChg>
        <pc:picChg chg="mod topLvl">
          <ac:chgData name="성균 박" userId="475b0f278f8dc192" providerId="LiveId" clId="{46C6B5B3-A706-4C4D-ADD1-BC25D55FF839}" dt="2024-11-12T00:54:03.592" v="311" actId="14100"/>
          <ac:picMkLst>
            <pc:docMk/>
            <pc:sldMk cId="452801974" sldId="263"/>
            <ac:picMk id="6" creationId="{1A3A7DD1-A576-C619-ACC7-76061BF171D3}"/>
          </ac:picMkLst>
        </pc:picChg>
      </pc:sldChg>
      <pc:sldChg chg="delSp modSp add mod">
        <pc:chgData name="성균 박" userId="475b0f278f8dc192" providerId="LiveId" clId="{46C6B5B3-A706-4C4D-ADD1-BC25D55FF839}" dt="2024-11-12T00:53:19.542" v="306" actId="14100"/>
        <pc:sldMkLst>
          <pc:docMk/>
          <pc:sldMk cId="1438885148" sldId="264"/>
        </pc:sldMkLst>
        <pc:spChg chg="mod topLvl">
          <ac:chgData name="성균 박" userId="475b0f278f8dc192" providerId="LiveId" clId="{46C6B5B3-A706-4C4D-ADD1-BC25D55FF839}" dt="2024-11-12T00:52:56.649" v="300" actId="165"/>
          <ac:spMkLst>
            <pc:docMk/>
            <pc:sldMk cId="1438885148" sldId="264"/>
            <ac:spMk id="7" creationId="{3FEF512C-FD89-5D0A-CA04-2049F69AD4E4}"/>
          </ac:spMkLst>
        </pc:spChg>
        <pc:spChg chg="mod topLvl">
          <ac:chgData name="성균 박" userId="475b0f278f8dc192" providerId="LiveId" clId="{46C6B5B3-A706-4C4D-ADD1-BC25D55FF839}" dt="2024-11-12T00:52:56.649" v="300" actId="165"/>
          <ac:spMkLst>
            <pc:docMk/>
            <pc:sldMk cId="1438885148" sldId="264"/>
            <ac:spMk id="8" creationId="{FCA80BF3-D13E-C98E-CF05-B15998F4DAB3}"/>
          </ac:spMkLst>
        </pc:spChg>
        <pc:spChg chg="mod topLvl">
          <ac:chgData name="성균 박" userId="475b0f278f8dc192" providerId="LiveId" clId="{46C6B5B3-A706-4C4D-ADD1-BC25D55FF839}" dt="2024-11-12T00:52:56.649" v="300" actId="165"/>
          <ac:spMkLst>
            <pc:docMk/>
            <pc:sldMk cId="1438885148" sldId="264"/>
            <ac:spMk id="9" creationId="{273D7B39-F6D1-63E6-F65C-5793A6D350D5}"/>
          </ac:spMkLst>
        </pc:spChg>
        <pc:spChg chg="mod topLvl">
          <ac:chgData name="성균 박" userId="475b0f278f8dc192" providerId="LiveId" clId="{46C6B5B3-A706-4C4D-ADD1-BC25D55FF839}" dt="2024-11-12T00:52:56.649" v="300" actId="165"/>
          <ac:spMkLst>
            <pc:docMk/>
            <pc:sldMk cId="1438885148" sldId="264"/>
            <ac:spMk id="12" creationId="{88ACFDEA-AC8E-99AD-2D32-23D424CAF9AA}"/>
          </ac:spMkLst>
        </pc:spChg>
        <pc:grpChg chg="del">
          <ac:chgData name="성균 박" userId="475b0f278f8dc192" providerId="LiveId" clId="{46C6B5B3-A706-4C4D-ADD1-BC25D55FF839}" dt="2024-11-12T00:52:56.649" v="300" actId="165"/>
          <ac:grpSpMkLst>
            <pc:docMk/>
            <pc:sldMk cId="1438885148" sldId="264"/>
            <ac:grpSpMk id="13" creationId="{71EDB585-1AF0-0D3F-E34D-5FD8BAF1AE41}"/>
          </ac:grpSpMkLst>
        </pc:grpChg>
        <pc:picChg chg="mod topLvl">
          <ac:chgData name="성균 박" userId="475b0f278f8dc192" providerId="LiveId" clId="{46C6B5B3-A706-4C4D-ADD1-BC25D55FF839}" dt="2024-11-12T00:53:19.542" v="306" actId="14100"/>
          <ac:picMkLst>
            <pc:docMk/>
            <pc:sldMk cId="1438885148" sldId="264"/>
            <ac:picMk id="6" creationId="{15BC6536-6D4D-F0E5-F3B2-A3E75761CD4B}"/>
          </ac:picMkLst>
        </pc:picChg>
      </pc:sldChg>
    </pc:docChg>
  </pc:docChgLst>
  <pc:docChgLst>
    <pc:chgData name="성균 박" userId="475b0f278f8dc192" providerId="LiveId" clId="{86484824-5742-4542-8005-F241FFE5E204}"/>
    <pc:docChg chg="modSld">
      <pc:chgData name="성균 박" userId="475b0f278f8dc192" providerId="LiveId" clId="{86484824-5742-4542-8005-F241FFE5E204}" dt="2024-09-12T10:04:19.981" v="40" actId="20577"/>
      <pc:docMkLst>
        <pc:docMk/>
      </pc:docMkLst>
      <pc:sldChg chg="modSp mod">
        <pc:chgData name="성균 박" userId="475b0f278f8dc192" providerId="LiveId" clId="{86484824-5742-4542-8005-F241FFE5E204}" dt="2024-09-12T10:04:19.981" v="40" actId="20577"/>
        <pc:sldMkLst>
          <pc:docMk/>
          <pc:sldMk cId="4177297690" sldId="261"/>
        </pc:sldMkLst>
        <pc:spChg chg="mod">
          <ac:chgData name="성균 박" userId="475b0f278f8dc192" providerId="LiveId" clId="{86484824-5742-4542-8005-F241FFE5E204}" dt="2024-09-12T10:04:19.981" v="40" actId="20577"/>
          <ac:spMkLst>
            <pc:docMk/>
            <pc:sldMk cId="4177297690" sldId="261"/>
            <ac:spMk id="4" creationId="{143F6CAA-F722-24A9-5DB1-820252810103}"/>
          </ac:spMkLst>
        </pc:spChg>
        <pc:spChg chg="mod">
          <ac:chgData name="성균 박" userId="475b0f278f8dc192" providerId="LiveId" clId="{86484824-5742-4542-8005-F241FFE5E204}" dt="2024-09-12T10:03:06.261" v="3" actId="20577"/>
          <ac:spMkLst>
            <pc:docMk/>
            <pc:sldMk cId="4177297690" sldId="261"/>
            <ac:spMk id="6" creationId="{8EE3AF49-2969-5489-DF95-ACDB492EC032}"/>
          </ac:spMkLst>
        </pc:spChg>
        <pc:spChg chg="mod">
          <ac:chgData name="성균 박" userId="475b0f278f8dc192" providerId="LiveId" clId="{86484824-5742-4542-8005-F241FFE5E204}" dt="2024-09-12T10:03:09.933" v="5" actId="20577"/>
          <ac:spMkLst>
            <pc:docMk/>
            <pc:sldMk cId="4177297690" sldId="261"/>
            <ac:spMk id="7" creationId="{FDCCDA69-2446-7E60-973A-67DE452044C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3AF4DD5-EF58-BD1A-E5D5-F5697DE730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130F5F3-BB09-8F77-23C7-6811015137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AE92874-5A6A-E764-2CD9-4510E454D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0BB0379-60EC-8D1B-AF75-583649597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E8D8730-6ADE-0907-74EC-C89C33729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393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2D235C3-9E40-CD63-DA5F-32580A9529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E9B6DCE-6C48-7ED1-DCC3-0A2B333532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20E8D9F-0D2F-954F-1574-0CB2B8AD0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278DA03-39F1-2C70-DFF4-14DC87F4B4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4C77E19-A850-6F36-AE53-BAB8721927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6290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7FD03D7-DDF5-4EB9-FB78-7DE9961543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C23BBB9-DAC6-8E98-3AF4-F6952149A8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A393A66-894D-FA49-CA87-216CB464E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34159DE-FFDF-5DC0-CBF7-3A5D545AE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DE585CC-6989-785C-72A9-63FDBFA27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9139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DF66320-1D44-FA59-D79A-5FCD404219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BC379EA-0B82-9DD3-6354-6DB96887AF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4F07012-446B-C1C3-BFC6-B071FD4A9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AED4B13-1586-3877-2B31-567AD99F9E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12EBAB3-8842-3C24-7597-59DB4A5A1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7220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BA507EB-8960-F4E4-1CA7-CE3AE1C14C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4E4243C-213D-A5EE-3E44-8F7646ED8B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0CF24EC-A5E1-6A4F-DC4B-41420E0CD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260027C-678A-B136-1770-11A7ADD151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38AC45D-B909-D9AE-26DE-DC1506039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169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549F1A0-90B9-6448-CA5F-9572B8496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013AF3C-7F08-18E9-DE92-B88CF6CEE3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770811C-1822-8E63-F36D-777E0B3A93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400B840-6D39-C65D-E1D7-D46EAFF05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9881E7B-93F5-703A-81A1-658C11DB9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A560057-0CA5-2FCC-F4E9-6AD3AC6C0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8555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4A87A26-C649-18AF-09AF-88383FFD4B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0944C0D-3184-767C-DE10-F2D674CD01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766C68B-9A9C-1C0D-75DD-B775BF6E12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3E62611-5C14-22FE-9776-F8B80AD572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0865057C-5D59-E2FB-41AB-41FCE82759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D73A37E-16E2-37B3-2F61-B0F4EBEB2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B230BFEB-7060-769D-82E5-CE2D99811B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0E915413-50AF-6844-0CC7-3563E1942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2230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458A961-1C65-CA37-A9EE-EF5E5D99A7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B1F534A8-862A-53FD-42D2-9AC43A333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8679E10-3E52-774D-F5A9-23F7E72B1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B71799D-8E93-2B68-DCA8-78B424F3D6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0247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28C8DD9-5EB5-C1D2-E2BF-4ADE92A9C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D64BE59-47EE-92A9-4ED6-3A41394A6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241F2136-5D1D-47DA-D235-B2036323C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290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B3E21A9-503E-EC26-492C-D8BE88ABD0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E88759A-E5C5-6AC3-512F-EE26D4C98D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276E033-A6F5-2846-54CB-102037156F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2609A76-8C4E-1277-9946-7BCFF7A30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0B3E190-E4B3-D92A-A698-5CE46132E4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C2946F4-AF92-33AF-730F-8B6F2DD36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3912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11AF511-11CC-6A60-C439-C3DA58B423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DE0AAB4C-741F-C8EB-56A6-D16D23846D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A826A02-B275-4435-E1CE-C288DE6202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E570997-53DE-0AA5-EABF-6E6312B96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7F13F47-B315-063E-8512-8E94269F5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FD8A996-F606-0602-D7A6-709EC27E9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4093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E4FE0499-6B04-4139-A6D3-DB90B7B36F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A6F9308-3C83-0F83-B835-07CC1DAD3E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486E84E-3251-C214-13BD-C978154B28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2328DD-3E38-44D8-83D9-9F0354589E92}" type="datetimeFigureOut">
              <a:rPr lang="ko-KR" altLang="en-US" smtClean="0"/>
              <a:t>2024-1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5AA57AD-27FD-79FE-386B-123F9BC03B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9F730CC-6EFD-6F84-310F-5077EB7FAA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D9423E-26B4-4A11-8EA6-D2F62612BDE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3746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43F6CAA-F722-24A9-5DB1-820252810103}"/>
              </a:ext>
            </a:extLst>
          </p:cNvPr>
          <p:cNvSpPr txBox="1"/>
          <p:nvPr/>
        </p:nvSpPr>
        <p:spPr>
          <a:xfrm>
            <a:off x="1390038" y="5148108"/>
            <a:ext cx="9657846" cy="17098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0">
              <a:lnSpc>
                <a:spcPct val="150000"/>
              </a:lnSpc>
            </a:pP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Figure S1. ROC curve analysis of 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ΔCT values.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(a) Aseptic specimens and (b) septic specimens compared with culture results of rare or more</a:t>
            </a:r>
            <a:r>
              <a:rPr lang="en-US" altLang="ko-KR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than rare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colonies.</a:t>
            </a:r>
          </a:p>
          <a:p>
            <a:pPr algn="just" latinLnBrk="0">
              <a:lnSpc>
                <a:spcPct val="150000"/>
              </a:lnSpc>
            </a:pPr>
            <a:r>
              <a:rPr lang="en-US" altLang="ko-KR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Abbreviations: Sens, sensitivity; Spec, specificity; PPV, positive predictive value; NPV, negative predictive value; AUC, area under curve</a:t>
            </a:r>
            <a:endParaRPr lang="ko-KR" altLang="ko-KR" sz="1800" kern="1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4B144AE9-0A4A-1218-00E0-F67959978B7D}"/>
              </a:ext>
            </a:extLst>
          </p:cNvPr>
          <p:cNvGrpSpPr/>
          <p:nvPr/>
        </p:nvGrpSpPr>
        <p:grpSpPr>
          <a:xfrm>
            <a:off x="984688" y="679647"/>
            <a:ext cx="9934836" cy="4552169"/>
            <a:chOff x="984688" y="679647"/>
            <a:chExt cx="9934836" cy="4552169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288AF067-C226-7338-6CCD-1D4EEA95A3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44738" y="690541"/>
              <a:ext cx="4619885" cy="4541275"/>
            </a:xfrm>
            <a:prstGeom prst="rect">
              <a:avLst/>
            </a:prstGeom>
          </p:spPr>
        </p:pic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AB9D207A-2B02-2B72-A0EC-18B3CFD188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288556" y="679647"/>
              <a:ext cx="4630968" cy="4552169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EE3AF49-2969-5489-DF95-ACDB492EC032}"/>
                </a:ext>
              </a:extLst>
            </p:cNvPr>
            <p:cNvSpPr txBox="1"/>
            <p:nvPr/>
          </p:nvSpPr>
          <p:spPr>
            <a:xfrm>
              <a:off x="984688" y="679647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(a)</a:t>
              </a:r>
              <a:endParaRPr lang="ko-KR" altLang="en-US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DCCDA69-2446-7E60-973A-67DE452044C9}"/>
                </a:ext>
              </a:extLst>
            </p:cNvPr>
            <p:cNvSpPr txBox="1"/>
            <p:nvPr/>
          </p:nvSpPr>
          <p:spPr>
            <a:xfrm>
              <a:off x="5939994" y="679647"/>
              <a:ext cx="4635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(b)</a:t>
              </a:r>
              <a:endParaRPr lang="ko-KR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41772976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420EE6F-C3F9-727E-E18E-F713570FA4E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1C7FF3FA-639F-8982-7CE1-2853C0326E57}"/>
              </a:ext>
            </a:extLst>
          </p:cNvPr>
          <p:cNvSpPr txBox="1"/>
          <p:nvPr/>
        </p:nvSpPr>
        <p:spPr>
          <a:xfrm>
            <a:off x="681352" y="5822462"/>
            <a:ext cx="10829295" cy="8735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</a:pP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2. </a:t>
            </a:r>
            <a:r>
              <a:rPr lang="en-US" altLang="ko-KR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difference in fungal broad-range PCR results according to bacterial ΔCT values in septic ocular specimen (n=97)</a:t>
            </a:r>
            <a:endParaRPr lang="en-US" altLang="ko-KR" sz="1800" kern="100" dirty="0">
              <a:effectLst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15BC6536-6D4D-F0E5-F3B2-A3E75761CD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49415" y="0"/>
            <a:ext cx="5908431" cy="582246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FEF512C-FD89-5D0A-CA04-2049F69AD4E4}"/>
              </a:ext>
            </a:extLst>
          </p:cNvPr>
          <p:cNvSpPr txBox="1"/>
          <p:nvPr/>
        </p:nvSpPr>
        <p:spPr>
          <a:xfrm>
            <a:off x="4131656" y="1773297"/>
            <a:ext cx="521518" cy="222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34.0 %</a:t>
            </a:r>
            <a:endParaRPr lang="ko-KR" altLang="en-US" sz="11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CA80BF3-D13E-C98E-CF05-B15998F4DAB3}"/>
              </a:ext>
            </a:extLst>
          </p:cNvPr>
          <p:cNvSpPr txBox="1"/>
          <p:nvPr/>
        </p:nvSpPr>
        <p:spPr>
          <a:xfrm>
            <a:off x="4131657" y="3342874"/>
            <a:ext cx="521518" cy="222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36.1 %</a:t>
            </a:r>
            <a:endParaRPr lang="ko-KR" altLang="en-US" sz="11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73D7B39-F6D1-63E6-F65C-5793A6D350D5}"/>
              </a:ext>
            </a:extLst>
          </p:cNvPr>
          <p:cNvSpPr txBox="1"/>
          <p:nvPr/>
        </p:nvSpPr>
        <p:spPr>
          <a:xfrm>
            <a:off x="6754207" y="4050528"/>
            <a:ext cx="521518" cy="222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0.6 %</a:t>
            </a:r>
            <a:endParaRPr lang="ko-KR" altLang="en-US" sz="11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8ACFDEA-AC8E-99AD-2D32-23D424CAF9AA}"/>
              </a:ext>
            </a:extLst>
          </p:cNvPr>
          <p:cNvSpPr txBox="1"/>
          <p:nvPr/>
        </p:nvSpPr>
        <p:spPr>
          <a:xfrm>
            <a:off x="6819533" y="3630355"/>
            <a:ext cx="456192" cy="222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9.3 %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4388851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4AA1206-766F-4FD9-EC7C-87007DF4ECF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8D82B95B-8B99-0465-294E-3573F3BEFE0E}"/>
              </a:ext>
            </a:extLst>
          </p:cNvPr>
          <p:cNvSpPr txBox="1"/>
          <p:nvPr/>
        </p:nvSpPr>
        <p:spPr>
          <a:xfrm>
            <a:off x="681352" y="5822462"/>
            <a:ext cx="10829295" cy="8735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</a:pP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3. </a:t>
            </a:r>
            <a:r>
              <a:rPr lang="en-US" altLang="ko-KR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difference in fungal broad-range PCR results according to bacterial ΔCT values </a:t>
            </a:r>
            <a:r>
              <a:rPr lang="en-US" altLang="ko-KR" b="0" i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 aseptic </a:t>
            </a:r>
            <a:r>
              <a:rPr lang="en-US" altLang="ko-KR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cular specimen (</a:t>
            </a:r>
            <a:r>
              <a:rPr lang="en-US" altLang="ko-KR" b="0" i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=54)</a:t>
            </a:r>
            <a:endParaRPr lang="en-US" altLang="ko-KR" sz="1800" kern="100" dirty="0">
              <a:effectLst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1A3A7DD1-A576-C619-ACC7-76061BF171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594708" y="0"/>
            <a:ext cx="5986584" cy="582246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99751F7-FDC0-A7F2-5E80-B6DA64CFCEFF}"/>
              </a:ext>
            </a:extLst>
          </p:cNvPr>
          <p:cNvSpPr txBox="1"/>
          <p:nvPr/>
        </p:nvSpPr>
        <p:spPr>
          <a:xfrm>
            <a:off x="4108209" y="3000274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9.6 %</a:t>
            </a:r>
            <a:endParaRPr lang="ko-KR" altLang="en-US" sz="11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32D4C8E-4E1A-A8DC-0B2D-45DAC1020DB2}"/>
              </a:ext>
            </a:extLst>
          </p:cNvPr>
          <p:cNvSpPr txBox="1"/>
          <p:nvPr/>
        </p:nvSpPr>
        <p:spPr>
          <a:xfrm>
            <a:off x="4108210" y="3749267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48.1 %</a:t>
            </a:r>
            <a:endParaRPr lang="ko-KR" altLang="en-US" sz="11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07CEB64-7ED9-BFEA-ED84-C43C7F43D764}"/>
              </a:ext>
            </a:extLst>
          </p:cNvPr>
          <p:cNvSpPr txBox="1"/>
          <p:nvPr/>
        </p:nvSpPr>
        <p:spPr>
          <a:xfrm>
            <a:off x="6730760" y="4707021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11.1 %</a:t>
            </a:r>
            <a:endParaRPr lang="ko-KR" altLang="en-US" sz="11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E3035FC-4162-4A88-D81C-EB8D9746D450}"/>
              </a:ext>
            </a:extLst>
          </p:cNvPr>
          <p:cNvSpPr txBox="1"/>
          <p:nvPr/>
        </p:nvSpPr>
        <p:spPr>
          <a:xfrm>
            <a:off x="6730759" y="4422658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11.1 %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4528019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130</Words>
  <Application>Microsoft Office PowerPoint</Application>
  <PresentationFormat>와이드스크린</PresentationFormat>
  <Paragraphs>14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맑은 고딕</vt:lpstr>
      <vt:lpstr>Arial</vt:lpstr>
      <vt:lpstr>Calibri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성균 박</dc:creator>
  <cp:lastModifiedBy>성균 박</cp:lastModifiedBy>
  <cp:revision>1</cp:revision>
  <dcterms:created xsi:type="dcterms:W3CDTF">2024-09-03T03:20:34Z</dcterms:created>
  <dcterms:modified xsi:type="dcterms:W3CDTF">2024-11-12T00:55:26Z</dcterms:modified>
</cp:coreProperties>
</file>